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79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 varScale="1">
        <p:scale>
          <a:sx n="85" d="100"/>
          <a:sy n="85" d="100"/>
        </p:scale>
        <p:origin x="3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EC13A9B-8D2B-F18D-5B02-6EAC11175E40}"/>
              </a:ext>
            </a:extLst>
          </p:cNvPr>
          <p:cNvSpPr txBox="1"/>
          <p:nvPr/>
        </p:nvSpPr>
        <p:spPr>
          <a:xfrm>
            <a:off x="0" y="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B7A7FE8-BA79-CDE2-13FF-55EC31954F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996" t="10356" r="23849" b="9615"/>
          <a:stretch/>
        </p:blipFill>
        <p:spPr>
          <a:xfrm>
            <a:off x="500768" y="369332"/>
            <a:ext cx="5128641" cy="837461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8E3F509-3CFC-1083-EB82-27F0D8AC0FDD}"/>
              </a:ext>
            </a:extLst>
          </p:cNvPr>
          <p:cNvSpPr txBox="1"/>
          <p:nvPr/>
        </p:nvSpPr>
        <p:spPr>
          <a:xfrm>
            <a:off x="221673" y="65058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9506D2-8506-9E66-27CB-50AAE2129DA1}"/>
              </a:ext>
            </a:extLst>
          </p:cNvPr>
          <p:cNvSpPr txBox="1"/>
          <p:nvPr/>
        </p:nvSpPr>
        <p:spPr>
          <a:xfrm>
            <a:off x="221673" y="476833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2D2E474-20FF-DFF2-7B46-464342D3FE4D}"/>
              </a:ext>
            </a:extLst>
          </p:cNvPr>
          <p:cNvSpPr txBox="1"/>
          <p:nvPr/>
        </p:nvSpPr>
        <p:spPr>
          <a:xfrm>
            <a:off x="200023" y="8743950"/>
            <a:ext cx="6486525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US" sz="9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4. Representative gating strategies of immune checkpoint and activation markers on CD4+ and CD8+ T cells </a:t>
            </a:r>
            <a:endParaRPr lang="fi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case showing the gating strategy used for the immunophenotyping of tumor, healthy kidney, pre-REP TIL and REP TIL CD4+ T cells using flow cytometry. First, CD4+ T cells were gated as in Supplementary Figure 3 and from them LAG+, PD1+, CD25+ and HLA-DR+ cells are gated based on their marker expressions.</a:t>
            </a:r>
            <a:endParaRPr lang="fi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case showing the gating strategy used for the immunophenotyping of tumor, healthy kidney, pre-REP TIL and REP TIL CD8+ T cells using flow cytometry. Gating done similarly as in panel A.</a:t>
            </a:r>
            <a:endParaRPr lang="fi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1652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37</TotalTime>
  <Words>127</Words>
  <Application>Microsoft Macintosh PowerPoint</Application>
  <PresentationFormat>A4-paperi (210 x 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6</cp:revision>
  <dcterms:created xsi:type="dcterms:W3CDTF">2022-10-13T13:05:53Z</dcterms:created>
  <dcterms:modified xsi:type="dcterms:W3CDTF">2023-06-17T07:16:20Z</dcterms:modified>
</cp:coreProperties>
</file>